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85" r:id="rId2"/>
    <p:sldId id="374" r:id="rId3"/>
    <p:sldId id="355" r:id="rId4"/>
    <p:sldId id="387" r:id="rId5"/>
    <p:sldId id="386" r:id="rId6"/>
  </p:sldIdLst>
  <p:sldSz cx="12192000" cy="6858000"/>
  <p:notesSz cx="6797675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Designformatvorlage 1 - Akz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ittlere Formatvorlage 4 - Akz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793D81CF-94F2-401A-BA57-92F5A7B2D0C5}" styleName="Mittlere Formatvorlag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Mittlere Formatvorlage 1 - Akz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52" autoAdjust="0"/>
    <p:restoredTop sz="96866" autoAdjust="0"/>
  </p:normalViewPr>
  <p:slideViewPr>
    <p:cSldViewPr snapToGrid="0">
      <p:cViewPr varScale="1">
        <p:scale>
          <a:sx n="84" d="100"/>
          <a:sy n="84" d="100"/>
        </p:scale>
        <p:origin x="-78" y="-5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60" cy="495348"/>
          </a:xfrm>
          <a:prstGeom prst="rect">
            <a:avLst/>
          </a:prstGeom>
        </p:spPr>
        <p:txBody>
          <a:bodyPr vert="horz" lIns="91815" tIns="45907" rIns="91815" bIns="45907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2" y="0"/>
            <a:ext cx="2945660" cy="495348"/>
          </a:xfrm>
          <a:prstGeom prst="rect">
            <a:avLst/>
          </a:prstGeom>
        </p:spPr>
        <p:txBody>
          <a:bodyPr vert="horz" lIns="91815" tIns="45907" rIns="91815" bIns="45907" rtlCol="0"/>
          <a:lstStyle>
            <a:lvl1pPr algn="r">
              <a:defRPr sz="1200"/>
            </a:lvl1pPr>
          </a:lstStyle>
          <a:p>
            <a:fld id="{C444010E-4504-44B1-A2E0-2AE3A69330D6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38150" y="1235075"/>
            <a:ext cx="5921375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815" tIns="45907" rIns="91815" bIns="45907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51220"/>
            <a:ext cx="5438140" cy="3887361"/>
          </a:xfrm>
          <a:prstGeom prst="rect">
            <a:avLst/>
          </a:prstGeom>
        </p:spPr>
        <p:txBody>
          <a:bodyPr vert="horz" lIns="91815" tIns="45907" rIns="91815" bIns="45907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945660" cy="495347"/>
          </a:xfrm>
          <a:prstGeom prst="rect">
            <a:avLst/>
          </a:prstGeom>
        </p:spPr>
        <p:txBody>
          <a:bodyPr vert="horz" lIns="91815" tIns="45907" rIns="91815" bIns="45907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2" y="9377317"/>
            <a:ext cx="2945660" cy="495347"/>
          </a:xfrm>
          <a:prstGeom prst="rect">
            <a:avLst/>
          </a:prstGeom>
        </p:spPr>
        <p:txBody>
          <a:bodyPr vert="horz" lIns="91815" tIns="45907" rIns="91815" bIns="45907" rtlCol="0" anchor="b"/>
          <a:lstStyle>
            <a:lvl1pPr algn="r">
              <a:defRPr sz="1200"/>
            </a:lvl1pPr>
          </a:lstStyle>
          <a:p>
            <a:fld id="{8DDF85D8-C4AC-45DE-93AD-3DE62BAA5EA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1985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DF85D8-C4AC-45DE-93AD-3DE62BAA5EA3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581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06891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9528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926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0563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9015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3659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5229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0813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3935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1295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1041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B6F7E-6468-46CA-9957-91BDEE778D1D}" type="datetimeFigureOut">
              <a:rPr lang="de-DE" smtClean="0"/>
              <a:t>15.09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EE499-E9C8-462E-B469-A3FF56A08EA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6199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tif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jpg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78"/>
          <a:stretch/>
        </p:blipFill>
        <p:spPr>
          <a:xfrm>
            <a:off x="5866366" y="738192"/>
            <a:ext cx="6010656" cy="3121057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05" b="49867"/>
          <a:stretch/>
        </p:blipFill>
        <p:spPr>
          <a:xfrm>
            <a:off x="0" y="581946"/>
            <a:ext cx="5673777" cy="3218084"/>
          </a:xfrm>
          <a:prstGeom prst="rect">
            <a:avLst/>
          </a:prstGeom>
        </p:spPr>
      </p:pic>
      <p:pic>
        <p:nvPicPr>
          <p:cNvPr id="4" name="Grafik 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78238" y="4121043"/>
            <a:ext cx="3504565" cy="2277110"/>
          </a:xfrm>
          <a:prstGeom prst="rect">
            <a:avLst/>
          </a:prstGeom>
          <a:noFill/>
        </p:spPr>
      </p:pic>
      <p:pic>
        <p:nvPicPr>
          <p:cNvPr id="5" name="Grafik 4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372" y="4130568"/>
            <a:ext cx="3515995" cy="2291715"/>
          </a:xfrm>
          <a:prstGeom prst="rect">
            <a:avLst/>
          </a:prstGeom>
          <a:noFill/>
        </p:spPr>
      </p:pic>
      <p:pic>
        <p:nvPicPr>
          <p:cNvPr id="6" name="Grafik 5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5805" y="4121043"/>
            <a:ext cx="3515995" cy="2286635"/>
          </a:xfrm>
          <a:prstGeom prst="rect">
            <a:avLst/>
          </a:prstGeom>
          <a:noFill/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C5130A19-4AAA-8741-BDFA-71895A35C59E}"/>
              </a:ext>
            </a:extLst>
          </p:cNvPr>
          <p:cNvSpPr txBox="1"/>
          <p:nvPr/>
        </p:nvSpPr>
        <p:spPr>
          <a:xfrm>
            <a:off x="4312714" y="107066"/>
            <a:ext cx="187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1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341534" y="82463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5771964" y="267129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02337" y="3760398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4174771" y="3743565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D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7853369" y="3742464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E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40491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2" t="26000" r="13764" b="23833"/>
          <a:stretch/>
        </p:blipFill>
        <p:spPr>
          <a:xfrm>
            <a:off x="3291841" y="1484114"/>
            <a:ext cx="4162046" cy="3687854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C5130A19-4AAA-8741-BDFA-71895A35C59E}"/>
              </a:ext>
            </a:extLst>
          </p:cNvPr>
          <p:cNvSpPr txBox="1"/>
          <p:nvPr/>
        </p:nvSpPr>
        <p:spPr>
          <a:xfrm>
            <a:off x="3498122" y="768504"/>
            <a:ext cx="187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2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4187805" y="1484114"/>
            <a:ext cx="200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TTLL4 mRNA </a:t>
            </a:r>
            <a:r>
              <a:rPr lang="de-DE" dirty="0" err="1" smtClean="0"/>
              <a:t>level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412071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3" t="27536" r="30685" b="26812"/>
          <a:stretch/>
        </p:blipFill>
        <p:spPr>
          <a:xfrm>
            <a:off x="350298" y="759437"/>
            <a:ext cx="2880852" cy="2808000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1150" y="3429000"/>
            <a:ext cx="3924681" cy="3254613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1827" y="3481262"/>
            <a:ext cx="4335231" cy="3202351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61"/>
          <a:stretch/>
        </p:blipFill>
        <p:spPr>
          <a:xfrm>
            <a:off x="7854288" y="1040636"/>
            <a:ext cx="4288845" cy="1958400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294" y="1057070"/>
            <a:ext cx="4269701" cy="1957456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290508" y="297772"/>
            <a:ext cx="187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3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731298" y="574771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557147" y="406656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7764995" y="340770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C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="" xmlns:a16="http://schemas.microsoft.com/office/drawing/2014/main" id="{E31E0D4C-D8E0-4889-9943-EE007C4196AB}"/>
              </a:ext>
            </a:extLst>
          </p:cNvPr>
          <p:cNvSpPr txBox="1"/>
          <p:nvPr/>
        </p:nvSpPr>
        <p:spPr>
          <a:xfrm>
            <a:off x="5201849" y="590334"/>
            <a:ext cx="1112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halloidin</a:t>
            </a:r>
            <a:endParaRPr lang="en-GB" dirty="0"/>
          </a:p>
        </p:txBody>
      </p:sp>
      <p:sp>
        <p:nvSpPr>
          <p:cNvPr id="16" name="Textfeld 15">
            <a:extLst>
              <a:ext uri="{FF2B5EF4-FFF2-40B4-BE49-F238E27FC236}">
                <a16:creationId xmlns="" xmlns:a16="http://schemas.microsoft.com/office/drawing/2014/main" id="{28C026E2-111D-46DE-B96E-1C4F1CB1DB79}"/>
              </a:ext>
            </a:extLst>
          </p:cNvPr>
          <p:cNvSpPr txBox="1"/>
          <p:nvPr/>
        </p:nvSpPr>
        <p:spPr>
          <a:xfrm>
            <a:off x="9649442" y="591322"/>
            <a:ext cx="662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VASP</a:t>
            </a:r>
            <a:endParaRPr lang="en-GB" dirty="0"/>
          </a:p>
        </p:txBody>
      </p:sp>
      <p:sp>
        <p:nvSpPr>
          <p:cNvPr id="17" name="Textfeld 16">
            <a:extLst>
              <a:ext uri="{FF2B5EF4-FFF2-40B4-BE49-F238E27FC236}">
                <a16:creationId xmlns="" xmlns:a16="http://schemas.microsoft.com/office/drawing/2014/main" id="{D55B20B0-F43A-4B82-8D70-2EE838279746}"/>
              </a:ext>
            </a:extLst>
          </p:cNvPr>
          <p:cNvSpPr txBox="1"/>
          <p:nvPr/>
        </p:nvSpPr>
        <p:spPr>
          <a:xfrm>
            <a:off x="5015713" y="3544063"/>
            <a:ext cx="111280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dirty="0" err="1"/>
              <a:t>Phalloidin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49644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19457" y="693307"/>
            <a:ext cx="16300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igure S4 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39" t="25652" r="24202" b="29566"/>
          <a:stretch/>
        </p:blipFill>
        <p:spPr>
          <a:xfrm>
            <a:off x="3764639" y="1644084"/>
            <a:ext cx="3447691" cy="3071191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5185796" y="1607084"/>
            <a:ext cx="1463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MDA-MB468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670917" y="1490086"/>
            <a:ext cx="29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4087016" y="1422418"/>
            <a:ext cx="282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393518" y="1422418"/>
            <a:ext cx="282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</a:t>
            </a:r>
            <a:endParaRPr lang="de-DE" dirty="0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2" t="25500" r="23382" b="25000"/>
          <a:stretch/>
        </p:blipFill>
        <p:spPr>
          <a:xfrm>
            <a:off x="260759" y="1828750"/>
            <a:ext cx="3202531" cy="30708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04"/>
          <a:stretch/>
        </p:blipFill>
        <p:spPr>
          <a:xfrm>
            <a:off x="7957012" y="1257982"/>
            <a:ext cx="2909777" cy="4029456"/>
          </a:xfrm>
          <a:prstGeom prst="rect">
            <a:avLst/>
          </a:prstGeom>
        </p:spPr>
      </p:pic>
      <p:cxnSp>
        <p:nvCxnSpPr>
          <p:cNvPr id="7" name="Gerader Verbinder 6"/>
          <p:cNvCxnSpPr/>
          <p:nvPr/>
        </p:nvCxnSpPr>
        <p:spPr>
          <a:xfrm flipH="1">
            <a:off x="8274570" y="3033859"/>
            <a:ext cx="11992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7614967" y="2846923"/>
            <a:ext cx="976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50 </a:t>
            </a:r>
            <a:r>
              <a:rPr lang="de-DE" dirty="0" err="1" smtClean="0"/>
              <a:t>kD</a:t>
            </a:r>
            <a:endParaRPr lang="de-DE" dirty="0"/>
          </a:p>
        </p:txBody>
      </p:sp>
      <p:cxnSp>
        <p:nvCxnSpPr>
          <p:cNvPr id="13" name="Gerader Verbinder 12"/>
          <p:cNvCxnSpPr/>
          <p:nvPr/>
        </p:nvCxnSpPr>
        <p:spPr>
          <a:xfrm flipH="1">
            <a:off x="8271522" y="2765635"/>
            <a:ext cx="11992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7630207" y="2578699"/>
            <a:ext cx="976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52 </a:t>
            </a:r>
            <a:r>
              <a:rPr lang="de-DE" dirty="0" err="1" smtClean="0"/>
              <a:t>kD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563659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3783" y="1314157"/>
            <a:ext cx="4411980" cy="3199331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804858" y="459578"/>
            <a:ext cx="1874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</a:t>
            </a:r>
            <a:r>
              <a:rPr lang="de-DE" dirty="0" smtClean="0"/>
              <a:t>S5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884868" y="1129491"/>
            <a:ext cx="1876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4921406" y="1129491"/>
            <a:ext cx="2823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76" t="29000" r="15207" b="26000"/>
          <a:stretch/>
        </p:blipFill>
        <p:spPr>
          <a:xfrm>
            <a:off x="978701" y="1446860"/>
            <a:ext cx="3920491" cy="308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5413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Custom</PresentationFormat>
  <Paragraphs>26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bine</dc:creator>
  <cp:lastModifiedBy>S3G_Reference_Citation_Sequence</cp:lastModifiedBy>
  <cp:revision>578</cp:revision>
  <cp:lastPrinted>2020-06-24T14:06:31Z</cp:lastPrinted>
  <dcterms:created xsi:type="dcterms:W3CDTF">2019-04-02T12:14:53Z</dcterms:created>
  <dcterms:modified xsi:type="dcterms:W3CDTF">2020-09-15T15:27:14Z</dcterms:modified>
</cp:coreProperties>
</file>